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78"/>
    <p:restoredTop sz="94694"/>
  </p:normalViewPr>
  <p:slideViewPr>
    <p:cSldViewPr snapToGrid="0" snapToObjects="1">
      <p:cViewPr>
        <p:scale>
          <a:sx n="122" d="100"/>
          <a:sy n="122" d="100"/>
        </p:scale>
        <p:origin x="81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F10F58-BA59-CD41-A1E4-60EC04BC7D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6A56E2-4B24-E647-9958-B0DC5F23D2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221905-A0F8-F94A-9C5E-9ABA0DB53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9EE156-FFA4-4B4D-BC27-1B1592C434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923E87-2B51-B942-8FD9-7B6A21553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534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CDE0CE-9565-A140-A512-46EFA0B389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B078A20-B2A3-C449-8E47-75FA97AB97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538436-7A66-AD42-81A9-65D498958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9943E0-9637-A746-9C64-C935D83665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B1CE59-EB27-0341-B078-26A1E59F07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7428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6D5A09C-D9FF-8248-A2C5-07748DE3D2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C41905-EADB-5348-8CD6-7CCE1EA0DF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D9F1F8-E73A-6A46-8942-CBF203C821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B86A39-9146-2D46-B1A6-B9491DA24F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166679-6A33-824A-A902-85948A0F7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4850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AC1D8F-C608-3D4E-97AC-D80578CB4E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536E3F-7EB1-124D-9BA4-F53DF7F65F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D39DC2-8EBF-074A-9AE9-189F92FB28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7D7459-E19C-D14B-B0E5-5441376262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7E26EC-2BEB-CC4E-9D08-FEE328BDF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478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C0692-F21B-ED4A-A8EF-2FDF6A1A19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73ED18-34E1-F740-920F-9D5BA5B098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633402-1249-CB45-83C9-6616AF129C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6E6A25-5699-6E42-AD76-D4E9BF7930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A8F3DD-643D-D645-AF7C-B59FCD025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154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F971EE-810E-3C4D-BA15-6B0F29BE37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943687-3C06-654E-B19C-59545310AA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3099CC-5449-7A45-8869-BE33AC6E43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FC5DEF-BA16-2F4B-8D31-D8B60440C6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89406C-90D1-D544-A8A6-1D4262EC2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30BB5A-E9EB-3A47-80E5-2D5803164F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1124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AADB5B-EA7D-3544-BAC2-22679BE113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3C832B-C237-DC42-8DF4-C389EBF196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FD3FB8-35D4-7249-ABA9-B6A1D41FC5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8124A40-CDF6-7443-A847-0A4B7B6D32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E78126B-33AC-164A-A1AC-FF8F1F112C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E297A76-6F03-DD48-90B7-3CFC5C3E8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EDF194E-91C6-A54A-BBFA-34BE3A531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0E9B65F-A246-DD47-95C6-79C27FCBB6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082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3F1D59-5115-E040-B70F-D25477D780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3CDAE0-C4CC-B942-917A-DDA31CD08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08CD513-55A6-EE42-9350-EC2FE44309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01CC3D-17C0-1B48-AEEA-FA1F6559E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292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B13E60E-62EF-4644-A377-277F731D8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016196B-8B5D-794E-A80D-83B20CC75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EF5AE89-6CFB-3F4F-89B3-839DD93B5B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505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94F5FB-EF3B-E24A-BE0C-4C8B10B154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D22ED6-3BD7-394E-B1E1-383684832D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4C406A-D918-4B45-9510-6AE4CB84EF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27367F-C28C-2241-8EFB-112B7E151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9FE32A-6048-624C-AE6B-8B66C9708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60D975-E222-3847-9BD2-420528DC1A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97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1A01FC-D946-994E-AACB-404C700A75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1B283E0-E1A2-6F4C-B4FB-89283C4D7D5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54B8D1-9FBE-0548-A96A-0C97F2C2DC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E4B366-1A4F-C041-BD80-2C0B50836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E6EF5A-5B49-3D4C-B348-F21D56464A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703E68-D0FB-0D4B-A499-7CBE43B2E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753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3BE43F6-E16E-0544-B901-56A2B79E65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248AEA-53B5-264C-9374-1FB9730FB9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8BB084-14F4-8342-B8B7-01DE5B41FB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1A687E-A80E-A241-A39D-0DA0DD93F86D}" type="datetimeFigureOut">
              <a:rPr lang="en-US" smtClean="0"/>
              <a:t>11/24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A4DF57-7505-104A-A2D7-F94EA6F3C4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69E70F-DC80-284D-9620-1FD35E515B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44A73D-5245-054F-8DB7-B89C2AE9B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666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0C8682-1E2F-B64F-BFC1-0C3C955B95E4}"/>
              </a:ext>
            </a:extLst>
          </p:cNvPr>
          <p:cNvSpPr txBox="1"/>
          <p:nvPr/>
        </p:nvSpPr>
        <p:spPr>
          <a:xfrm>
            <a:off x="0" y="0"/>
            <a:ext cx="317580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loyd Lab – Drake: 0000300,303</a:t>
            </a:r>
          </a:p>
          <a:p>
            <a:r>
              <a:rPr lang="en-US" dirty="0"/>
              <a:t>HeLa</a:t>
            </a:r>
          </a:p>
          <a:p>
            <a:pPr marL="285750" indent="-285750">
              <a:buFontTx/>
              <a:buChar char="-"/>
            </a:pPr>
            <a:r>
              <a:rPr lang="en-US" dirty="0"/>
              <a:t>WT</a:t>
            </a:r>
          </a:p>
          <a:p>
            <a:pPr marL="285750" indent="-285750">
              <a:buFontTx/>
              <a:buChar char="-"/>
            </a:pPr>
            <a:r>
              <a:rPr lang="en-US" dirty="0"/>
              <a:t>pCW57-mCherry-2A-Iso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84D4AB6-5B47-644A-84F1-926A93A7FF7C}"/>
              </a:ext>
            </a:extLst>
          </p:cNvPr>
          <p:cNvSpPr txBox="1"/>
          <p:nvPr/>
        </p:nvSpPr>
        <p:spPr>
          <a:xfrm>
            <a:off x="2608205" y="2830944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D4 Iso 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612F0AB-E099-3247-8FC2-AB1AD9FF871E}"/>
              </a:ext>
            </a:extLst>
          </p:cNvPr>
          <p:cNvSpPr txBox="1"/>
          <p:nvPr/>
        </p:nvSpPr>
        <p:spPr>
          <a:xfrm>
            <a:off x="2608205" y="3309503"/>
            <a:ext cx="1192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D4 Iso 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6CA2B8-DE03-BE42-B615-EE38E5EE7696}"/>
              </a:ext>
            </a:extLst>
          </p:cNvPr>
          <p:cNvSpPr txBox="1"/>
          <p:nvPr/>
        </p:nvSpPr>
        <p:spPr>
          <a:xfrm>
            <a:off x="2392709" y="3819325"/>
            <a:ext cx="1418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NAPII pSer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AD50897-FAEE-E547-8182-2406A4E612AA}"/>
              </a:ext>
            </a:extLst>
          </p:cNvPr>
          <p:cNvSpPr txBox="1"/>
          <p:nvPr/>
        </p:nvSpPr>
        <p:spPr>
          <a:xfrm>
            <a:off x="2925471" y="4306380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buli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5810BA7-413E-DB42-94A3-C4C1D35AF1EE}"/>
              </a:ext>
            </a:extLst>
          </p:cNvPr>
          <p:cNvSpPr txBox="1"/>
          <p:nvPr/>
        </p:nvSpPr>
        <p:spPr>
          <a:xfrm>
            <a:off x="4671223" y="2425371"/>
            <a:ext cx="639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so 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EABD1AB-59F4-7D4B-84A1-FD29CA0438A1}"/>
              </a:ext>
            </a:extLst>
          </p:cNvPr>
          <p:cNvSpPr txBox="1"/>
          <p:nvPr/>
        </p:nvSpPr>
        <p:spPr>
          <a:xfrm>
            <a:off x="3980202" y="2438583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</a:t>
            </a:r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2"/>
          <a:srcRect t="1" r="74869" b="6136"/>
          <a:stretch/>
        </p:blipFill>
        <p:spPr>
          <a:xfrm>
            <a:off x="3808191" y="3847310"/>
            <a:ext cx="1509287" cy="25950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3" name="Picture 62"/>
          <p:cNvPicPr>
            <a:picLocks noChangeAspect="1"/>
          </p:cNvPicPr>
          <p:nvPr/>
        </p:nvPicPr>
        <p:blipFill rotWithShape="1">
          <a:blip r:embed="rId3"/>
          <a:srcRect t="9801" r="74905" b="8961"/>
          <a:stretch/>
        </p:blipFill>
        <p:spPr>
          <a:xfrm>
            <a:off x="3811688" y="3244880"/>
            <a:ext cx="1499454" cy="45056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4" name="Picture 63"/>
          <p:cNvPicPr>
            <a:picLocks noChangeAspect="1"/>
          </p:cNvPicPr>
          <p:nvPr/>
        </p:nvPicPr>
        <p:blipFill rotWithShape="1">
          <a:blip r:embed="rId4"/>
          <a:srcRect t="1" r="75041" b="644"/>
          <a:stretch/>
        </p:blipFill>
        <p:spPr>
          <a:xfrm>
            <a:off x="3825378" y="2833070"/>
            <a:ext cx="1485764" cy="283377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5" name="Picture 64"/>
          <p:cNvPicPr>
            <a:picLocks noChangeAspect="1"/>
          </p:cNvPicPr>
          <p:nvPr/>
        </p:nvPicPr>
        <p:blipFill rotWithShape="1">
          <a:blip r:embed="rId5"/>
          <a:srcRect t="1" r="72239" b="851"/>
          <a:stretch/>
        </p:blipFill>
        <p:spPr>
          <a:xfrm flipV="1">
            <a:off x="3814227" y="4245946"/>
            <a:ext cx="1496916" cy="48603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203808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0C8682-1E2F-B64F-BFC1-0C3C955B95E4}"/>
              </a:ext>
            </a:extLst>
          </p:cNvPr>
          <p:cNvSpPr txBox="1"/>
          <p:nvPr/>
        </p:nvSpPr>
        <p:spPr>
          <a:xfrm>
            <a:off x="0" y="0"/>
            <a:ext cx="317580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loyd Lab – Drake: 0000300,303</a:t>
            </a:r>
          </a:p>
          <a:p>
            <a:r>
              <a:rPr lang="en-US" dirty="0"/>
              <a:t>HeLa</a:t>
            </a:r>
          </a:p>
          <a:p>
            <a:pPr marL="285750" indent="-285750">
              <a:buFontTx/>
              <a:buChar char="-"/>
            </a:pPr>
            <a:r>
              <a:rPr lang="en-US" dirty="0"/>
              <a:t>WT</a:t>
            </a:r>
          </a:p>
          <a:p>
            <a:pPr marL="285750" indent="-285750">
              <a:buFontTx/>
              <a:buChar char="-"/>
            </a:pPr>
            <a:r>
              <a:rPr lang="en-US" dirty="0"/>
              <a:t>pCW57-mCherry-2A-Iso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84D4AB6-5B47-644A-84F1-926A93A7FF7C}"/>
              </a:ext>
            </a:extLst>
          </p:cNvPr>
          <p:cNvSpPr txBox="1"/>
          <p:nvPr/>
        </p:nvSpPr>
        <p:spPr>
          <a:xfrm>
            <a:off x="2728310" y="2362858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D4 Iso 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612F0AB-E099-3247-8FC2-AB1AD9FF871E}"/>
              </a:ext>
            </a:extLst>
          </p:cNvPr>
          <p:cNvSpPr txBox="1"/>
          <p:nvPr/>
        </p:nvSpPr>
        <p:spPr>
          <a:xfrm>
            <a:off x="2737928" y="3546791"/>
            <a:ext cx="1192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D4 Iso 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6CA2B8-DE03-BE42-B615-EE38E5EE7696}"/>
              </a:ext>
            </a:extLst>
          </p:cNvPr>
          <p:cNvSpPr txBox="1"/>
          <p:nvPr/>
        </p:nvSpPr>
        <p:spPr>
          <a:xfrm>
            <a:off x="2525613" y="2079851"/>
            <a:ext cx="1418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NAPII pSer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5810BA7-413E-DB42-94A3-C4C1D35AF1EE}"/>
              </a:ext>
            </a:extLst>
          </p:cNvPr>
          <p:cNvSpPr txBox="1"/>
          <p:nvPr/>
        </p:nvSpPr>
        <p:spPr>
          <a:xfrm>
            <a:off x="8018497" y="1681153"/>
            <a:ext cx="639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so 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EABD1AB-59F4-7D4B-84A1-FD29CA0438A1}"/>
              </a:ext>
            </a:extLst>
          </p:cNvPr>
          <p:cNvSpPr txBox="1"/>
          <p:nvPr/>
        </p:nvSpPr>
        <p:spPr>
          <a:xfrm>
            <a:off x="6804962" y="1710519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5B5A3AA-ABCC-D744-A941-15493448BF1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44591" y="2169357"/>
            <a:ext cx="4864100" cy="312420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7B825DA-3F73-D24F-B01B-07EBA1FB275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3934"/>
          <a:stretch/>
        </p:blipFill>
        <p:spPr>
          <a:xfrm>
            <a:off x="9982199" y="2169357"/>
            <a:ext cx="1113029" cy="33655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ADA79663-E49E-B043-B3AE-4FA1A24DDA74}"/>
              </a:ext>
            </a:extLst>
          </p:cNvPr>
          <p:cNvSpPr txBox="1"/>
          <p:nvPr/>
        </p:nvSpPr>
        <p:spPr>
          <a:xfrm>
            <a:off x="5078356" y="5542744"/>
            <a:ext cx="30331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RD4 (green), RNAPIIpS2 (red)</a:t>
            </a:r>
          </a:p>
        </p:txBody>
      </p:sp>
    </p:spTree>
    <p:extLst>
      <p:ext uri="{BB962C8B-B14F-4D97-AF65-F5344CB8AC3E}">
        <p14:creationId xmlns:p14="http://schemas.microsoft.com/office/powerpoint/2010/main" val="37540304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20C8682-1E2F-B64F-BFC1-0C3C955B95E4}"/>
              </a:ext>
            </a:extLst>
          </p:cNvPr>
          <p:cNvSpPr txBox="1"/>
          <p:nvPr/>
        </p:nvSpPr>
        <p:spPr>
          <a:xfrm>
            <a:off x="0" y="0"/>
            <a:ext cx="317580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loyd Lab – Drake: 0000300,303</a:t>
            </a:r>
          </a:p>
          <a:p>
            <a:r>
              <a:rPr lang="en-US" dirty="0"/>
              <a:t>HeLa</a:t>
            </a:r>
          </a:p>
          <a:p>
            <a:pPr marL="285750" indent="-285750">
              <a:buFontTx/>
              <a:buChar char="-"/>
            </a:pPr>
            <a:r>
              <a:rPr lang="en-US" dirty="0"/>
              <a:t>WT</a:t>
            </a:r>
          </a:p>
          <a:p>
            <a:pPr marL="285750" indent="-285750">
              <a:buFontTx/>
              <a:buChar char="-"/>
            </a:pPr>
            <a:r>
              <a:rPr lang="en-US" dirty="0"/>
              <a:t>pCW57-mCherry-2A-Iso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84D4AB6-5B47-644A-84F1-926A93A7FF7C}"/>
              </a:ext>
            </a:extLst>
          </p:cNvPr>
          <p:cNvSpPr txBox="1"/>
          <p:nvPr/>
        </p:nvSpPr>
        <p:spPr>
          <a:xfrm>
            <a:off x="3646926" y="2320817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ubuli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5810BA7-413E-DB42-94A3-C4C1D35AF1EE}"/>
              </a:ext>
            </a:extLst>
          </p:cNvPr>
          <p:cNvSpPr txBox="1"/>
          <p:nvPr/>
        </p:nvSpPr>
        <p:spPr>
          <a:xfrm>
            <a:off x="7791534" y="883923"/>
            <a:ext cx="639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so 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EABD1AB-59F4-7D4B-84A1-FD29CA0438A1}"/>
              </a:ext>
            </a:extLst>
          </p:cNvPr>
          <p:cNvSpPr txBox="1"/>
          <p:nvPr/>
        </p:nvSpPr>
        <p:spPr>
          <a:xfrm>
            <a:off x="6689348" y="883923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T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7B825DA-3F73-D24F-B01B-07EBA1FB275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3934"/>
          <a:stretch/>
        </p:blipFill>
        <p:spPr>
          <a:xfrm>
            <a:off x="9982199" y="2169357"/>
            <a:ext cx="1113029" cy="33655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55ACF5DD-E87C-3A44-A14F-90C8010289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83995" y="1371600"/>
            <a:ext cx="4000500" cy="411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32932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</TotalTime>
  <Words>62</Words>
  <Application>Microsoft Macintosh PowerPoint</Application>
  <PresentationFormat>Widescreen</PresentationFormat>
  <Paragraphs>2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ake Edwards</dc:creator>
  <cp:lastModifiedBy>Drake Edwards</cp:lastModifiedBy>
  <cp:revision>22</cp:revision>
  <dcterms:created xsi:type="dcterms:W3CDTF">2019-05-24T20:16:53Z</dcterms:created>
  <dcterms:modified xsi:type="dcterms:W3CDTF">2019-11-24T21:04:49Z</dcterms:modified>
</cp:coreProperties>
</file>